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80" r:id="rId12"/>
    <p:sldId id="267" r:id="rId13"/>
    <p:sldId id="270" r:id="rId14"/>
    <p:sldId id="269" r:id="rId15"/>
    <p:sldId id="268" r:id="rId16"/>
    <p:sldId id="271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A9A078-511F-40C6-9BEE-6DA2F185A2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C822A48-238C-4196-A290-3FA17008BB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D9B7F0-70E2-41C4-83C8-9CFDCFE53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6F1101-3B85-4CC7-98E0-01602E71E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34A07C-D362-49A2-8DCE-0359C28FD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787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DB1321-7327-4734-9598-EAF243E71D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E3C468-A93D-4623-8DCF-88AB318D38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85E018-67FA-4286-8703-45491250E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0094DB-1717-4148-84EE-BD145D1890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24FBB2-85FF-425E-97A4-A430477A9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505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05384F-9960-423D-BCE5-2C3EB535DE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975778-9FE8-4496-934C-D76723168E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05CD50-26E3-42A7-AB82-68D40F224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FEBB88-1A92-4116-A139-87D33F65C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8B3272-3030-4887-9CF7-E1B700F30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209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F06312-130D-4DDE-8AE2-EF9E8F9888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FEAD84-A910-41A2-9EE4-F00140387E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74058D-2FF2-4FBD-8060-C09C274C24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718635-709A-4F10-8AF1-EDB00B764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ECE411-B257-4251-B37F-7D8EE6744B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756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187923-4FFB-4DD9-8258-902CFED6DC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8AE939-4772-440E-915E-3A7F2925C9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CFA406-C4D0-451D-A292-8159D9671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4A94ED-D775-4EC1-982E-9EDD9A7C7B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48A8E2-D657-46BF-BE77-B6B7057E9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157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B1E7C0-BCCE-4BDF-A228-569F5E2144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51DCC2-6F74-4160-9F6C-B82C20D23B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353207-2580-4FDF-9473-BC278C63E8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8D9E14-C836-4FA6-B9E8-398292BEB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6A9592-A98E-4895-9B0F-FF1476CE98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2BCCD9-0CFF-4986-A63D-5AEB62366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856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139FDE-EB6D-47CB-802C-83615853B2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762445-CB74-4DC5-8B1A-B0FBEE4F21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4DFA2D-B386-4412-83C8-B60014B110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98D4D8E-290E-4803-B046-AFC0927663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19CEA88-9E95-41B4-BDE8-56D7688909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191BF1-A843-4E94-BBA1-0E3CE8AC8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A3FBE27-E5C8-42BB-AF92-7A237F68FD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205C1D-5480-4E7E-9832-DEC0A303E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302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3D7EC6-A760-4034-BF65-72C01696DE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F7CF72-ED21-43E3-AB8D-2F132546C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C1DD38-4A0F-4989-BBF8-8E05653DF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7023DF-FE75-4AEF-8BAA-F910C29B2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19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968D48-2E1E-47E8-9F66-0BF7DC3D03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3681DD-58F0-41D0-B5C6-B4AF32F82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B2CA10-8BD1-4862-82A4-B82BC3A4E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79CE80-9B0D-46F3-8736-842A197CB6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8C3A9B-678A-462D-8A21-AAB2670634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50A9F0-6124-4716-BD38-1A53DF5054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8534A6-37B0-4002-95B3-8B5581247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AAA66C-3AB9-4D75-A0E5-CFD183D34D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B5E18A-64EC-45D2-909D-D5A59FD4D4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75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831256-034C-4BCB-853C-766A19274B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41F766-731F-4570-9843-E32F8EE04C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41C21D-1D4F-4339-AE8F-A5EB6F3C79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E62F23-0FCA-442C-B5F2-5E13AE191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369E32-629F-4F57-8DD9-49F423F94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5D73F0-DED9-4FF6-A670-54EAFCCA7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936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4073DBE-701F-4F17-AB59-3E61C5882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B08C17-B99A-4A17-85DB-5263571A4F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E99FAF-B246-4CFF-AAD4-0255E2B45A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B6F520-DC66-4AF1-A250-493707457D11}" type="datetimeFigureOut">
              <a:rPr lang="en-US" smtClean="0"/>
              <a:t>4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C1DE58-20F3-498E-91B3-F192BE08C8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594720-ECAC-4920-9A24-1302F3175F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819DD-9DED-4ACA-9593-F23F187344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835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58A448C6-444D-43F5-9F17-821F531F84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670893" cy="6858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C43010C-C98F-4441-BE83-9EBB72D602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73867" y="80683"/>
            <a:ext cx="6018133" cy="67773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628397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8EBB8B9-FF96-4569-B372-64C54FC727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142571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EC2C135-1618-41C3-AD0D-326E077256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82540" y="0"/>
            <a:ext cx="540946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778663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8D463E5-7FF7-4FEA-AF27-E9605828F5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437050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923FC38-495D-40A0-8AB2-FF8E9C4C03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10472" y="0"/>
            <a:ext cx="478910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31430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A8A4E4F-6D61-4523-A63F-36F945FCE5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356412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D8CCCB6-E366-4C8E-AF8A-2D24DA42EF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33443" y="0"/>
            <a:ext cx="575855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660094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DAC2C69-7E66-4A34-B892-D4CE9CFDC1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80682"/>
            <a:ext cx="5887457" cy="677731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598998E-DEA6-45C0-8F8D-4E74279A2A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90542" y="0"/>
            <a:ext cx="542059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316367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9F0F924-0007-419A-BDB6-EDB6822BE8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232918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9FE5F2F-31AA-45E0-9F20-44FB2A95DC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00614" y="0"/>
            <a:ext cx="629138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020198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A9A1725-B31B-4EE9-B821-5E6F3EAEEF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5" y="0"/>
            <a:ext cx="5927008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18A1E04-F62A-4DF9-A77E-36C7414FA0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4712" y="0"/>
            <a:ext cx="554347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859252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2E87D29-2004-4BFC-921C-A93FB3EC67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-13563"/>
            <a:ext cx="5432612" cy="687916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83F73A3-FB63-4CF7-806E-D081261566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2433" y="0"/>
            <a:ext cx="568670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48208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CBE602F-4889-4D76-9138-F6456C3C5C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182115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1AE2B14-D07F-406E-BD96-37F7486150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27616" y="0"/>
            <a:ext cx="646438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67874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F6547D6-EFA0-48D5-8848-C52ED603A6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261234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9DB2C86-60DE-4CA1-B7A7-2CC7432287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39006" y="0"/>
            <a:ext cx="568815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44007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A1F6F32-7E57-4346-8D37-A59E042C7F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910113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221B339-32D5-4D28-A946-F05FC17103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99567" y="0"/>
            <a:ext cx="589243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65315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9F1BACA-C0DA-432C-8E0F-64AD0BD34C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707970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354470E-EC18-4DDE-BC7C-8452917D09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97396" y="0"/>
            <a:ext cx="579460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81831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D666DD0-C3CF-49CC-A43D-A5A1D55FC6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014458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36CEF58-7E67-46D3-A7F5-482E381055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55907" y="0"/>
            <a:ext cx="543609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08878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A9D3281-4544-4307-A8A6-9D90E78450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691161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545ED41-D5A2-4F48-8E04-06E0B20893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8757" y="0"/>
            <a:ext cx="593324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99931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6884920-550B-4034-997E-E088EB5FD7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136105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B0A9E7A-AB3B-42CD-8C00-3308464FB2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34788" y="0"/>
            <a:ext cx="555721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802981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92E1825-8CA0-4763-88B0-5C0D609654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4708234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0EDBB3C-9DBE-43D1-9370-BD9613611A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7520" y="0"/>
            <a:ext cx="554888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5396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5</TotalTime>
  <Words>0</Words>
  <Application>Microsoft Office PowerPoint</Application>
  <PresentationFormat>Widescreen</PresentationFormat>
  <Paragraphs>0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javid Aghayev</dc:creator>
  <cp:lastModifiedBy>Mirjavid Aghayev</cp:lastModifiedBy>
  <cp:revision>21</cp:revision>
  <dcterms:created xsi:type="dcterms:W3CDTF">2025-04-06T23:33:46Z</dcterms:created>
  <dcterms:modified xsi:type="dcterms:W3CDTF">2025-04-09T18:57:12Z</dcterms:modified>
</cp:coreProperties>
</file>